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ander Dils" initials="AD" lastIdx="1" clrIdx="0">
    <p:extLst>
      <p:ext uri="{19B8F6BF-5375-455C-9EA6-DF929625EA0E}">
        <p15:presenceInfo xmlns:p15="http://schemas.microsoft.com/office/powerpoint/2012/main" userId="c784099f4177c7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655" autoAdjust="0"/>
    <p:restoredTop sz="90062" autoAdjust="0"/>
  </p:normalViewPr>
  <p:slideViewPr>
    <p:cSldViewPr snapToGrid="0">
      <p:cViewPr varScale="1">
        <p:scale>
          <a:sx n="53" d="100"/>
          <a:sy n="53" d="100"/>
        </p:scale>
        <p:origin x="176" y="720"/>
      </p:cViewPr>
      <p:guideLst>
        <p:guide orient="horz" pos="112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7" d="100"/>
        <a:sy n="147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E029D0-E746-4642-BD9A-E771A539E169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1130CC-2589-4178-9C25-726388E64E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24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>
              <a:buAutoNum type="alphaUcPeriod" startAt="3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1130CC-2589-4178-9C25-726388E64E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457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3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555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78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736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96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476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968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17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11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145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813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80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723FB3F5-0D4B-4D67-82E0-DD8D947A8AF8}"/>
              </a:ext>
            </a:extLst>
          </p:cNvPr>
          <p:cNvSpPr txBox="1"/>
          <p:nvPr/>
        </p:nvSpPr>
        <p:spPr>
          <a:xfrm>
            <a:off x="0" y="5447103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Sel1L loss does not alter frequency of peripheral regulatory T cel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) Representative flow cytometric analysis of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2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gs in splenic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WT and Sel1LKO mice. B) Frequency of FoxP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gs among peripheral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WT and Sel1LKO mice, aged 6-10wks. Data representative of n=6-7/genotype, 3 independent experiments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7003753-322A-409D-BAF9-5B882FCB2BCA}"/>
              </a:ext>
            </a:extLst>
          </p:cNvPr>
          <p:cNvGrpSpPr/>
          <p:nvPr/>
        </p:nvGrpSpPr>
        <p:grpSpPr>
          <a:xfrm>
            <a:off x="1853245" y="793533"/>
            <a:ext cx="3012364" cy="2026202"/>
            <a:chOff x="82865" y="317816"/>
            <a:chExt cx="3012364" cy="202620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1D51827F-BB29-4B84-9BD6-7D3DB00BD6C1}"/>
                </a:ext>
              </a:extLst>
            </p:cNvPr>
            <p:cNvGrpSpPr/>
            <p:nvPr/>
          </p:nvGrpSpPr>
          <p:grpSpPr>
            <a:xfrm>
              <a:off x="244471" y="390721"/>
              <a:ext cx="2850758" cy="1953297"/>
              <a:chOff x="-41279" y="2020132"/>
              <a:chExt cx="2850758" cy="1953297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1968A9B2-6448-4A6F-9F72-E08A967CA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5181" y="2937377"/>
                <a:ext cx="914400" cy="914400"/>
              </a:xfrm>
              <a:prstGeom prst="rect">
                <a:avLst/>
              </a:prstGeom>
            </p:spPr>
          </p:pic>
          <p:pic>
            <p:nvPicPr>
              <p:cNvPr id="5" name="Picture 4" descr="A picture containing letter&#10;&#10;Description automatically generated">
                <a:extLst>
                  <a:ext uri="{FF2B5EF4-FFF2-40B4-BE49-F238E27FC236}">
                    <a16:creationId xmlns:a16="http://schemas.microsoft.com/office/drawing/2014/main" id="{1A92D6CF-A9A8-494B-B587-CA18A3D575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4076" y="2075268"/>
                <a:ext cx="914400" cy="914400"/>
              </a:xfrm>
              <a:prstGeom prst="rect">
                <a:avLst/>
              </a:prstGeom>
            </p:spPr>
          </p:pic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12EB40CC-0093-41D5-8EF2-ADD6E1F6DCDC}"/>
                  </a:ext>
                </a:extLst>
              </p:cNvPr>
              <p:cNvGrpSpPr/>
              <p:nvPr/>
            </p:nvGrpSpPr>
            <p:grpSpPr>
              <a:xfrm>
                <a:off x="-41279" y="2167465"/>
                <a:ext cx="1081258" cy="1805964"/>
                <a:chOff x="2254501" y="4919410"/>
                <a:chExt cx="1081258" cy="1805964"/>
              </a:xfrm>
            </p:grpSpPr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CCD7D0FF-3E3D-4B81-93F4-9E778249259A}"/>
                    </a:ext>
                  </a:extLst>
                </p:cNvPr>
                <p:cNvSpPr txBox="1"/>
                <p:nvPr/>
              </p:nvSpPr>
              <p:spPr>
                <a:xfrm>
                  <a:off x="2256906" y="6029702"/>
                  <a:ext cx="31931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762C6B8E-CCF5-4352-86B6-3ACAB4424782}"/>
                    </a:ext>
                  </a:extLst>
                </p:cNvPr>
                <p:cNvSpPr txBox="1"/>
                <p:nvPr/>
              </p:nvSpPr>
              <p:spPr>
                <a:xfrm>
                  <a:off x="2254501" y="5156789"/>
                  <a:ext cx="32412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cxnSp>
              <p:nvCxnSpPr>
                <p:cNvPr id="18" name="Straight Arrow Connector 17">
                  <a:extLst>
                    <a:ext uri="{FF2B5EF4-FFF2-40B4-BE49-F238E27FC236}">
                      <a16:creationId xmlns:a16="http://schemas.microsoft.com/office/drawing/2014/main" id="{AA030DE4-F2E9-46ED-8466-016BDB7831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586692" y="6217878"/>
                  <a:ext cx="3008" cy="414009"/>
                </a:xfrm>
                <a:prstGeom prst="straightConnector1">
                  <a:avLst/>
                </a:prstGeom>
                <a:ln w="1270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4E8A83EE-66D9-46DB-846E-6E03BD0FAF8E}"/>
                    </a:ext>
                  </a:extLst>
                </p:cNvPr>
                <p:cNvSpPr txBox="1"/>
                <p:nvPr/>
              </p:nvSpPr>
              <p:spPr>
                <a:xfrm>
                  <a:off x="2923467" y="6525319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25</a:t>
                  </a:r>
                </a:p>
              </p:txBody>
            </p:sp>
            <p:cxnSp>
              <p:nvCxnSpPr>
                <p:cNvPr id="20" name="Straight Arrow Connector 19">
                  <a:extLst>
                    <a:ext uri="{FF2B5EF4-FFF2-40B4-BE49-F238E27FC236}">
                      <a16:creationId xmlns:a16="http://schemas.microsoft.com/office/drawing/2014/main" id="{5E8AC1CA-206A-4B17-80F5-5D8F161212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82628" y="6631210"/>
                  <a:ext cx="374417" cy="0"/>
                </a:xfrm>
                <a:prstGeom prst="straightConnector1">
                  <a:avLst/>
                </a:prstGeom>
                <a:ln w="1270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6E2D7117-12F6-4B31-BC68-19ADDB8C23F8}"/>
                    </a:ext>
                  </a:extLst>
                </p:cNvPr>
                <p:cNvSpPr txBox="1"/>
                <p:nvPr/>
              </p:nvSpPr>
              <p:spPr>
                <a:xfrm rot="16200000">
                  <a:off x="2371707" y="5905721"/>
                  <a:ext cx="44275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oxP3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8CC8F4F1-6CFD-42AD-8320-44263C929C59}"/>
                    </a:ext>
                  </a:extLst>
                </p:cNvPr>
                <p:cNvSpPr txBox="1"/>
                <p:nvPr/>
              </p:nvSpPr>
              <p:spPr>
                <a:xfrm>
                  <a:off x="2869704" y="4919410"/>
                  <a:ext cx="33534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.0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BBB7DC1E-F44E-4B9F-8612-1D08B2728804}"/>
                    </a:ext>
                  </a:extLst>
                </p:cNvPr>
                <p:cNvSpPr txBox="1"/>
                <p:nvPr/>
              </p:nvSpPr>
              <p:spPr>
                <a:xfrm>
                  <a:off x="2869704" y="5782306"/>
                  <a:ext cx="33534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.6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35FA01F1-8402-4301-B80C-EF0B3A6A0BB6}"/>
                  </a:ext>
                </a:extLst>
              </p:cNvPr>
              <p:cNvGrpSpPr/>
              <p:nvPr/>
            </p:nvGrpSpPr>
            <p:grpSpPr>
              <a:xfrm>
                <a:off x="1549182" y="2020132"/>
                <a:ext cx="1260297" cy="1943138"/>
                <a:chOff x="1536044" y="3985760"/>
                <a:chExt cx="1260297" cy="1943138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C1106AD9-A759-488D-BB42-5E3262992FF1}"/>
                    </a:ext>
                  </a:extLst>
                </p:cNvPr>
                <p:cNvSpPr txBox="1"/>
                <p:nvPr/>
              </p:nvSpPr>
              <p:spPr>
                <a:xfrm rot="16200000">
                  <a:off x="833116" y="4836020"/>
                  <a:ext cx="160591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FoxP3+ of CD4+ T cells</a:t>
                  </a:r>
                </a:p>
              </p:txBody>
            </p: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EE9D6EB8-39BD-4D63-8CC4-2944781E8E41}"/>
                    </a:ext>
                  </a:extLst>
                </p:cNvPr>
                <p:cNvGrpSpPr/>
                <p:nvPr/>
              </p:nvGrpSpPr>
              <p:grpSpPr>
                <a:xfrm>
                  <a:off x="1649771" y="3985760"/>
                  <a:ext cx="1146570" cy="1943138"/>
                  <a:chOff x="1672631" y="3985760"/>
                  <a:chExt cx="1146570" cy="1943138"/>
                </a:xfrm>
              </p:grpSpPr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C57CD2A2-29D8-43D1-9484-B23AA3CF7CEB}"/>
                      </a:ext>
                    </a:extLst>
                  </p:cNvPr>
                  <p:cNvGrpSpPr/>
                  <p:nvPr/>
                </p:nvGrpSpPr>
                <p:grpSpPr>
                  <a:xfrm>
                    <a:off x="1962092" y="5725369"/>
                    <a:ext cx="591134" cy="203529"/>
                    <a:chOff x="1613436" y="6581851"/>
                    <a:chExt cx="591134" cy="203529"/>
                  </a:xfrm>
                </p:grpSpPr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27984D74-AD9B-442F-9B0A-0DC539E11B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90060" y="6581851"/>
                      <a:ext cx="31451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O</a:t>
                      </a:r>
                    </a:p>
                  </p:txBody>
                </p:sp>
                <p:sp>
                  <p:nvSpPr>
                    <p:cNvPr id="15" name="TextBox 14">
                      <a:extLst>
                        <a:ext uri="{FF2B5EF4-FFF2-40B4-BE49-F238E27FC236}">
                          <a16:creationId xmlns:a16="http://schemas.microsoft.com/office/drawing/2014/main" id="{63957BBF-8705-4ECC-9870-65114A85AD3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3436" y="6585325"/>
                      <a:ext cx="324128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p:txBody>
                </p:sp>
              </p:grpSp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D04DABBF-FB05-47DE-B5F5-CDE84C837F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10642"/>
                  <a:stretch/>
                </p:blipFill>
                <p:spPr>
                  <a:xfrm>
                    <a:off x="1672631" y="3985760"/>
                    <a:ext cx="1146570" cy="1789687"/>
                  </a:xfrm>
                  <a:prstGeom prst="rect">
                    <a:avLst/>
                  </a:prstGeom>
                </p:spPr>
              </p:pic>
            </p:grpSp>
          </p:grp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58D1A92-988F-4B7F-80C8-7031C58202F9}"/>
                </a:ext>
              </a:extLst>
            </p:cNvPr>
            <p:cNvSpPr txBox="1"/>
            <p:nvPr/>
          </p:nvSpPr>
          <p:spPr>
            <a:xfrm>
              <a:off x="82865" y="317816"/>
              <a:ext cx="5675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03E80C8E-C014-0948-918B-EF980FDBA079}"/>
              </a:ext>
            </a:extLst>
          </p:cNvPr>
          <p:cNvSpPr txBox="1"/>
          <p:nvPr/>
        </p:nvSpPr>
        <p:spPr>
          <a:xfrm>
            <a:off x="3358333" y="793533"/>
            <a:ext cx="567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5AFF5B0B-D4AF-2D4D-B271-141CBC7DCF31}"/>
              </a:ext>
            </a:extLst>
          </p:cNvPr>
          <p:cNvGrpSpPr/>
          <p:nvPr/>
        </p:nvGrpSpPr>
        <p:grpSpPr>
          <a:xfrm>
            <a:off x="4385917" y="1005207"/>
            <a:ext cx="389301" cy="316993"/>
            <a:chOff x="-819558" y="688364"/>
            <a:chExt cx="389301" cy="316993"/>
          </a:xfrm>
        </p:grpSpPr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F6AE1606-7E86-D64A-AA5C-509B4EA88D03}"/>
                </a:ext>
              </a:extLst>
            </p:cNvPr>
            <p:cNvSpPr/>
            <p:nvPr/>
          </p:nvSpPr>
          <p:spPr>
            <a:xfrm>
              <a:off x="-819558" y="728765"/>
              <a:ext cx="91440" cy="91440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FD65106D-AD58-2A4F-A6E4-742E56344EEA}"/>
                </a:ext>
              </a:extLst>
            </p:cNvPr>
            <p:cNvSpPr/>
            <p:nvPr/>
          </p:nvSpPr>
          <p:spPr>
            <a:xfrm>
              <a:off x="-819558" y="839425"/>
              <a:ext cx="91440" cy="91440"/>
            </a:xfrm>
            <a:prstGeom prst="rect">
              <a:avLst/>
            </a:prstGeom>
            <a:solidFill>
              <a:srgbClr val="AC0000">
                <a:alpha val="60000"/>
              </a:srgb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563970A-C6B2-2D46-A66E-7E291CA31E12}"/>
                </a:ext>
              </a:extLst>
            </p:cNvPr>
            <p:cNvSpPr txBox="1"/>
            <p:nvPr/>
          </p:nvSpPr>
          <p:spPr>
            <a:xfrm>
              <a:off x="-754385" y="688364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1317E48-F004-584C-9133-287D6A2F797E}"/>
                </a:ext>
              </a:extLst>
            </p:cNvPr>
            <p:cNvSpPr txBox="1"/>
            <p:nvPr/>
          </p:nvSpPr>
          <p:spPr>
            <a:xfrm>
              <a:off x="-756852" y="805302"/>
              <a:ext cx="3145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B082068F-825D-6F4B-898A-1EE5412F1C01}"/>
              </a:ext>
            </a:extLst>
          </p:cNvPr>
          <p:cNvSpPr txBox="1"/>
          <p:nvPr/>
        </p:nvSpPr>
        <p:spPr>
          <a:xfrm>
            <a:off x="2377637" y="827411"/>
            <a:ext cx="8602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CD4 T cells</a:t>
            </a:r>
          </a:p>
        </p:txBody>
      </p:sp>
    </p:spTree>
    <p:extLst>
      <p:ext uri="{BB962C8B-B14F-4D97-AF65-F5344CB8AC3E}">
        <p14:creationId xmlns:p14="http://schemas.microsoft.com/office/powerpoint/2010/main" val="3694332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45</TotalTime>
  <Words>102</Words>
  <Application>Microsoft Macintosh PowerPoint</Application>
  <PresentationFormat>Letter Paper (8.5x11 in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>University of Michigan Health System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Carty, Shannon</dc:creator>
  <cp:keywords/>
  <dc:description/>
  <cp:lastModifiedBy>Carty, Shannon</cp:lastModifiedBy>
  <cp:revision>458</cp:revision>
  <cp:lastPrinted>2021-04-26T17:38:41Z</cp:lastPrinted>
  <dcterms:created xsi:type="dcterms:W3CDTF">2020-10-13T17:58:26Z</dcterms:created>
  <dcterms:modified xsi:type="dcterms:W3CDTF">2021-05-22T21:59:28Z</dcterms:modified>
  <cp:category/>
</cp:coreProperties>
</file>